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92"/>
  </p:normalViewPr>
  <p:slideViewPr>
    <p:cSldViewPr snapToGrid="0" snapToObjects="1">
      <p:cViewPr varScale="1">
        <p:scale>
          <a:sx n="90" d="100"/>
          <a:sy n="90" d="100"/>
        </p:scale>
        <p:origin x="80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/Users/georgia/Desktop/Pathology_2019/10.Manuscript_Preparation/hnRNPA_Manuscript/hnRNAP1_CH/hnRNPA1%20data/Auswertung%20hnRNPA1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7114186484265"/>
          <c:y val="4.1083099906629401E-2"/>
          <c:w val="0.70847928099896496"/>
          <c:h val="0.67722240602278105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Marker vs ERG'!$D$13</c:f>
              <c:strCache>
                <c:ptCount val="1"/>
                <c:pt idx="0">
                  <c:v>weak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multiLvlStrRef>
              <c:f>'Marker vs ERG'!$A$14:$B$17</c:f>
              <c:multiLvlStrCache>
                <c:ptCount val="4"/>
                <c:lvl>
                  <c:pt idx="0">
                    <c:v>ERG negative (n=5142)</c:v>
                  </c:pt>
                  <c:pt idx="1">
                    <c:v>ERG positive (n=4141)</c:v>
                  </c:pt>
                  <c:pt idx="2">
                    <c:v>ERG normal (n=3393)</c:v>
                  </c:pt>
                  <c:pt idx="3">
                    <c:v>ERG BA (n=2803)</c:v>
                  </c:pt>
                </c:lvl>
                <c:lvl>
                  <c:pt idx="0">
                    <c:v>ERG-IHC p&lt;0.0001</c:v>
                  </c:pt>
                  <c:pt idx="2">
                    <c:v>ERG-FISH p&lt;0.0001</c:v>
                  </c:pt>
                </c:lvl>
              </c:multiLvlStrCache>
            </c:multiLvlStrRef>
          </c:cat>
          <c:val>
            <c:numRef>
              <c:f>'Marker vs ERG'!$D$14:$D$17</c:f>
              <c:numCache>
                <c:formatCode>#,#00</c:formatCode>
                <c:ptCount val="4"/>
                <c:pt idx="0">
                  <c:v>23.356670556203813</c:v>
                </c:pt>
                <c:pt idx="1">
                  <c:v>7.4861144651050466</c:v>
                </c:pt>
                <c:pt idx="2">
                  <c:v>21.131741821396993</c:v>
                </c:pt>
                <c:pt idx="3">
                  <c:v>6.5643952907598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A8-3044-8840-6139CB5C0BF9}"/>
            </c:ext>
          </c:extLst>
        </c:ser>
        <c:ser>
          <c:idx val="4"/>
          <c:order val="1"/>
          <c:tx>
            <c:strRef>
              <c:f>'Marker vs ERG'!$E$13</c:f>
              <c:strCache>
                <c:ptCount val="1"/>
                <c:pt idx="0">
                  <c:v>modera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cat>
            <c:multiLvlStrRef>
              <c:f>'Marker vs ERG'!$A$14:$B$17</c:f>
              <c:multiLvlStrCache>
                <c:ptCount val="4"/>
                <c:lvl>
                  <c:pt idx="0">
                    <c:v>ERG negative (n=5142)</c:v>
                  </c:pt>
                  <c:pt idx="1">
                    <c:v>ERG positive (n=4141)</c:v>
                  </c:pt>
                  <c:pt idx="2">
                    <c:v>ERG normal (n=3393)</c:v>
                  </c:pt>
                  <c:pt idx="3">
                    <c:v>ERG BA (n=2803)</c:v>
                  </c:pt>
                </c:lvl>
                <c:lvl>
                  <c:pt idx="0">
                    <c:v>ERG-IHC p&lt;0.0001</c:v>
                  </c:pt>
                  <c:pt idx="2">
                    <c:v>ERG-FISH p&lt;0.0001</c:v>
                  </c:pt>
                </c:lvl>
              </c:multiLvlStrCache>
            </c:multiLvlStrRef>
          </c:cat>
          <c:val>
            <c:numRef>
              <c:f>'Marker vs ERG'!$E$14:$E$17</c:f>
              <c:numCache>
                <c:formatCode>#,#00</c:formatCode>
                <c:ptCount val="4"/>
                <c:pt idx="0">
                  <c:v>40.081680280046669</c:v>
                </c:pt>
                <c:pt idx="1">
                  <c:v>46.945182323110359</c:v>
                </c:pt>
                <c:pt idx="2">
                  <c:v>43.913940465664602</c:v>
                </c:pt>
                <c:pt idx="3">
                  <c:v>47.591865858009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7A8-3044-8840-6139CB5C0BF9}"/>
            </c:ext>
          </c:extLst>
        </c:ser>
        <c:ser>
          <c:idx val="5"/>
          <c:order val="2"/>
          <c:tx>
            <c:strRef>
              <c:f>'Marker vs ERG'!$F$13</c:f>
              <c:strCache>
                <c:ptCount val="1"/>
                <c:pt idx="0">
                  <c:v>strong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cat>
            <c:multiLvlStrRef>
              <c:f>'Marker vs ERG'!$A$14:$B$17</c:f>
              <c:multiLvlStrCache>
                <c:ptCount val="4"/>
                <c:lvl>
                  <c:pt idx="0">
                    <c:v>ERG negative (n=5142)</c:v>
                  </c:pt>
                  <c:pt idx="1">
                    <c:v>ERG positive (n=4141)</c:v>
                  </c:pt>
                  <c:pt idx="2">
                    <c:v>ERG normal (n=3393)</c:v>
                  </c:pt>
                  <c:pt idx="3">
                    <c:v>ERG BA (n=2803)</c:v>
                  </c:pt>
                </c:lvl>
                <c:lvl>
                  <c:pt idx="0">
                    <c:v>ERG-IHC p&lt;0.0001</c:v>
                  </c:pt>
                  <c:pt idx="2">
                    <c:v>ERG-FISH p&lt;0.0001</c:v>
                  </c:pt>
                </c:lvl>
              </c:multiLvlStrCache>
            </c:multiLvlStrRef>
          </c:cat>
          <c:val>
            <c:numRef>
              <c:f>'Marker vs ERG'!$F$14:$F$17</c:f>
              <c:numCache>
                <c:formatCode>#,#00</c:formatCode>
                <c:ptCount val="4"/>
                <c:pt idx="0">
                  <c:v>25.670945157526255</c:v>
                </c:pt>
                <c:pt idx="1">
                  <c:v>44.747645496256943</c:v>
                </c:pt>
                <c:pt idx="2">
                  <c:v>28.58826996758031</c:v>
                </c:pt>
                <c:pt idx="3">
                  <c:v>45.2729218694256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7A8-3044-8840-6139CB5C0BF9}"/>
            </c:ext>
          </c:extLst>
        </c:ser>
        <c:ser>
          <c:idx val="0"/>
          <c:order val="3"/>
          <c:tx>
            <c:strRef>
              <c:f>'Marker vs ERG'!$G$13</c:f>
              <c:strCache>
                <c:ptCount val="1"/>
                <c:pt idx="0">
                  <c:v>negativ2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  <a:prstDash val="sysDash"/>
            </a:ln>
          </c:spPr>
          <c:invertIfNegative val="0"/>
          <c:cat>
            <c:multiLvlStrRef>
              <c:f>'Marker vs ERG'!$A$14:$B$17</c:f>
              <c:multiLvlStrCache>
                <c:ptCount val="4"/>
                <c:lvl>
                  <c:pt idx="0">
                    <c:v>ERG negative (n=5142)</c:v>
                  </c:pt>
                  <c:pt idx="1">
                    <c:v>ERG positive (n=4141)</c:v>
                  </c:pt>
                  <c:pt idx="2">
                    <c:v>ERG normal (n=3393)</c:v>
                  </c:pt>
                  <c:pt idx="3">
                    <c:v>ERG BA (n=2803)</c:v>
                  </c:pt>
                </c:lvl>
                <c:lvl>
                  <c:pt idx="0">
                    <c:v>ERG-IHC p&lt;0.0001</c:v>
                  </c:pt>
                  <c:pt idx="2">
                    <c:v>ERG-FISH p&lt;0.0001</c:v>
                  </c:pt>
                </c:lvl>
              </c:multiLvlStrCache>
            </c:multiLvlStrRef>
          </c:cat>
          <c:val>
            <c:numRef>
              <c:f>'Marker vs ERG'!$G$14:$G$17</c:f>
              <c:numCache>
                <c:formatCode>#,#00</c:formatCode>
                <c:ptCount val="4"/>
                <c:pt idx="0">
                  <c:v>10.89070400622326</c:v>
                </c:pt>
                <c:pt idx="1">
                  <c:v>0.82105771552765039</c:v>
                </c:pt>
                <c:pt idx="2">
                  <c:v>6.3660477453580899</c:v>
                </c:pt>
                <c:pt idx="3">
                  <c:v>0.570816981805208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7A8-3044-8840-6139CB5C0B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32523136"/>
        <c:axId val="132524672"/>
      </c:barChart>
      <c:catAx>
        <c:axId val="1325231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de-DE"/>
          </a:p>
        </c:txPr>
        <c:crossAx val="132524672"/>
        <c:crosses val="autoZero"/>
        <c:auto val="1"/>
        <c:lblAlgn val="ctr"/>
        <c:lblOffset val="100"/>
        <c:noMultiLvlLbl val="0"/>
      </c:catAx>
      <c:valAx>
        <c:axId val="132524672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 b="1" i="0" u="none" strike="noStrike" baseline="0">
                    <a:effectLst/>
                  </a:rPr>
                  <a:t>Fraction of samples (%)</a:t>
                </a:r>
                <a:endParaRPr lang="de-DE" sz="1200"/>
              </a:p>
            </c:rich>
          </c:tx>
          <c:overlay val="0"/>
        </c:title>
        <c:numFmt formatCode="#,#00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de-DE"/>
          </a:p>
        </c:txPr>
        <c:crossAx val="132523136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30598572480598196"/>
          <c:y val="0.93713057281279133"/>
          <c:w val="0.35520364810513794"/>
          <c:h val="5.7534634202747049E-2"/>
        </c:manualLayout>
      </c:layout>
      <c:overlay val="0"/>
      <c:txPr>
        <a:bodyPr/>
        <a:lstStyle/>
        <a:p>
          <a:pPr>
            <a:defRPr sz="1200"/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00">
          <a:latin typeface="Arial"/>
          <a:cs typeface="Arial"/>
        </a:defRPr>
      </a:pPr>
      <a:endParaRPr lang="de-DE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1BDDF7-1FAA-234D-A2F4-FA23DB404E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63FDBA-D050-1D4F-8C2C-B51014A3C0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BC0803-8120-5849-BCEF-7F4B41D0D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1F49CC-D373-534D-B567-44684FB832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1C97C2-BB65-2040-AC32-83A030B19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2290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E216EC-FC87-674A-806F-F0CA003F0F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B95E8C-CDCB-CB4E-A6A0-28B751AC03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6F92EB-7F28-6943-A64F-B784032D2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BEEDC4-81BE-E54B-BB76-29306A111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0FBA93-BDBA-2441-880C-CE225B4BC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1661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91EEAD-7815-8040-BB35-9B477E77E2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89B883-AF81-1140-BDDF-2195A226FB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D57479-88A5-1C4A-B24A-00E310D4A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9CDFCA-75B3-4340-8EBF-C41EB7846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3DA05-9975-8947-9ED0-6E3191984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6849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70129-4511-ED4B-9E2E-FD8B4C297B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F62E73-F52E-704A-8FA1-1D6AACE6C4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2A43B7-F5BF-F443-B2D9-D76B2FD8A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66888A-B819-5344-9AF8-7ABB72814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131A10-BD55-394A-AFF7-9C7C3AB26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483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19C18B-F378-5846-999C-8669C0DAEE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37517F-C390-4548-8C27-B99908852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5B7380-14CE-F441-80BD-2DFE83BC2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BB247E-479B-DC45-813A-098F00547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947205-265D-FC44-84F2-E42378779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6852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B394B9-75EE-5D48-A91A-D5731FA16A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CA98C6-EC4B-2A47-8F36-E32654B600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3443B4-B762-DF40-AA1B-65AEDDF484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3C46C8-0051-0342-ADC4-F022831D1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85BA2F-767B-1743-A880-A026CED60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455123-BADE-E74A-B306-14F19A05B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1584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8D31F3-7823-B844-9374-36489409A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A88CAE-E821-2E46-83F3-16FB969733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D231C2-C98C-9D48-9508-BA1F5EE231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EA6CA7-5633-9245-AD82-2E4E7205E1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84DBA3-A8F4-AD44-BF10-CB11B79982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B8F34D-E67E-9E41-8448-A0FEEC1182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35FC65-F755-AB41-84F0-50A17EFF9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7E91A5-7D17-0F4F-ACBA-ACE80EA0F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2890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986712-997A-EB4D-86CB-4A86A55912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F83B00-47E9-E741-BAFF-F74E97DBF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2B418C3-5A52-DC42-95F0-2544CBDE79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F9BBAE3-0C2A-C249-AC11-499CC4EF9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6514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609C73-12D6-5141-AB79-E18CF767FB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D32683A-08C2-964E-97DB-9C4177A828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6AE5CA1-B5F8-CD42-A4C6-65E3C0F37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9520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E498D7-67AE-CB4E-BBAC-FB3E217D2E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AE184B-5C0D-DB40-9EAD-2D7E52B176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93AA03-41B4-4F4B-B3FC-CAA98AF6D1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332F5B-FCF4-2E47-AE63-5BCD5F4CF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531E78-2D1F-3E4B-AEA0-CCDFB06A7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F95CB4-B9F1-D646-B85A-AC8E7D46BB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5400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251332-8F09-E944-9656-6DE0698E86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9EB639-8736-5F43-BD2E-4FC21F0D58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8E7949-53C5-BA4C-A46C-3A4314144B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351495-45CC-5345-825A-B84965909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AEAC11-9308-6640-9BCA-19D38A4507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F3B8B4-947D-AE4D-924E-C9C5D1F25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9086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613535-B606-844E-860F-2B03F76325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A494EB-A11E-1E41-8784-75ED6FE875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39A01A-D81E-1744-8E77-842EC10022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5F9E0-8075-1B45-90A2-AD7FDC1A0BB6}" type="datetimeFigureOut">
              <a:rPr lang="de-DE" smtClean="0"/>
              <a:t>23.12.19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D639F6-E513-0346-9EAA-432A8C0A31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608D02-8BBB-6F49-B3D9-1FE4798A0F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2D6DE-3235-0645-8B1C-D54B8C76AC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2234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m 1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9271986"/>
              </p:ext>
            </p:extLst>
          </p:nvPr>
        </p:nvGraphicFramePr>
        <p:xfrm>
          <a:off x="1682750" y="2101651"/>
          <a:ext cx="8826500" cy="42548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B69F797B-546F-4940-A1C8-0EAE4AFBB08F}"/>
              </a:ext>
            </a:extLst>
          </p:cNvPr>
          <p:cNvSpPr/>
          <p:nvPr/>
        </p:nvSpPr>
        <p:spPr>
          <a:xfrm>
            <a:off x="2062163" y="501451"/>
            <a:ext cx="7639050" cy="4989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. 1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nRNPA1 immunostaining and TMPRSS2:ERG fusion status (IHC/FISH)</a:t>
            </a:r>
            <a:endParaRPr lang="de-DE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6153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1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1</cp:revision>
  <dcterms:created xsi:type="dcterms:W3CDTF">2019-11-29T19:21:41Z</dcterms:created>
  <dcterms:modified xsi:type="dcterms:W3CDTF">2019-12-23T10:42:11Z</dcterms:modified>
</cp:coreProperties>
</file>